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0C6613-2E40-44C2-930B-17904956008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DE29D8-50DF-4269-A937-A5AD31FE7E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26C28D-574C-405E-883E-C083711E6F0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83E562-5045-4D4F-8CC0-7C0F3D4CAE1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19A4D7-A577-434A-8BAB-918EA7D9CE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67E140-FE60-41A2-A895-255C3BDB2D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15AF24-6052-4CC0-85D0-06ADCB76C8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894AB7-1405-4394-AD3C-F8A82B73CB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1EF9D0-FC71-4CAB-88C3-821F412379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BBD91A-A6DC-488D-9954-9B1384813C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0CF895-C7AB-4BDC-ACA2-012C310453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883FAE-957C-4041-82F8-8974BC8C80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66BEB87-DC55-41B5-AB47-EFAF9BE3D55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890640" y="7056360"/>
            <a:ext cx="4770360" cy="169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000" spc="-1" strike="noStrike">
                <a:solidFill>
                  <a:srgbClr val="000000"/>
                </a:solidFill>
                <a:latin typeface="Arial"/>
              </a:rPr>
              <a:t>Figure S1.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 Visual pigment relative absorbances for dwarf chameleons and birds.  A) the Cape dwarf chameleon, </a:t>
            </a:r>
            <a:r>
              <a:rPr b="0" i="1" lang="en-AU" sz="1000" spc="-1" strike="noStrike">
                <a:solidFill>
                  <a:srgbClr val="000000"/>
                </a:solidFill>
                <a:latin typeface="Arial"/>
              </a:rPr>
              <a:t>Bradypodion pumilum 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</a:rPr>
              <a:t>(Loew and Felishman, unpublished data; details provided in Stuart-Fox et al. 2007; B) Ultra-violet sensitive avian visual system and C) violet-sensitive avian visual system. UVS – ultra-violet sensitive; VS – violet sensitive; SWS – short wavelength sensitive; MWS – medium wavelength sensitive; LWS – long wavelength sensitive; D – double cone. Absorbance spectra of the single cones are corrected for ocular media transmission and oil droplet absorbance and have been normalized to equal area under the curve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907920" y="755640"/>
            <a:ext cx="3324240" cy="6078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2-13T22:15:49Z</dcterms:created>
  <dc:creator>devis</dc:creator>
  <dc:description/>
  <dc:language>en-US</dc:language>
  <cp:lastModifiedBy>devis</cp:lastModifiedBy>
  <dcterms:modified xsi:type="dcterms:W3CDTF">2007-12-13T22:17:11Z</dcterms:modified>
  <cp:revision>1</cp:revision>
  <dc:subject/>
  <dc:title>Slide 1</dc:title>
</cp:coreProperties>
</file>